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78F572-D73C-4800-BBF9-03C8C1531A0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5D70AF-343E-436F-BE96-F5E00E434A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8E06F-4184-45C1-A45F-B7D4DB3AE7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D88A3-3B53-4D41-B531-0C9B6F716D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537C3E-3116-4922-9E56-88C6DF9CB7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730DD2-0EC5-4DF2-8E80-3A0B99D6F2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6651DF-DACC-47FC-A0C8-D6DFFAAADC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D73EEC-5365-402D-9A8C-48D183FAE6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D47D1B-958A-40D0-8505-FE842E4BAB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B154E8-8411-4B7A-BC11-41AFBD3FD3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16D005-28E2-4DEF-AE8C-6DB4B98099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BD9D14-D6E7-4787-859E-C683D8F589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474E70-D7BC-4AD7-8D7E-EF7B3F22122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66560" y="45720"/>
            <a:ext cx="8121240" cy="8038080"/>
            <a:chOff x="466560" y="45720"/>
            <a:chExt cx="8121240" cy="8038080"/>
          </a:xfrm>
        </p:grpSpPr>
        <p:grpSp>
          <p:nvGrpSpPr>
            <p:cNvPr id="42" name=""/>
            <p:cNvGrpSpPr/>
            <p:nvPr/>
          </p:nvGrpSpPr>
          <p:grpSpPr>
            <a:xfrm>
              <a:off x="4048200" y="704520"/>
              <a:ext cx="4539600" cy="7379280"/>
              <a:chOff x="4048200" y="704520"/>
              <a:chExt cx="4539600" cy="7379280"/>
            </a:xfrm>
          </p:grpSpPr>
          <p:pic>
            <p:nvPicPr>
              <p:cNvPr id="43" name="" descr=""/>
              <p:cNvPicPr/>
              <p:nvPr/>
            </p:nvPicPr>
            <p:blipFill>
              <a:blip r:embed="rId1"/>
              <a:srcRect l="7014" t="2707" r="14951" b="3476"/>
              <a:stretch/>
            </p:blipFill>
            <p:spPr>
              <a:xfrm>
                <a:off x="5032080" y="1001520"/>
                <a:ext cx="3555720" cy="4086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"/>
              <p:cNvSpPr/>
              <p:nvPr/>
            </p:nvSpPr>
            <p:spPr>
              <a:xfrm>
                <a:off x="4098600" y="704520"/>
                <a:ext cx="14745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B. terbinafine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4048200" y="1419120"/>
                <a:ext cx="1061640" cy="666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200000"/>
                  </a:lnSpc>
                  <a:tabLst>
                    <a:tab algn="l" pos="0"/>
                    <a:tab algn="ctr" pos="228600"/>
                    <a:tab algn="ctr" pos="74628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0.09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0.5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200000"/>
                  </a:lnSpc>
                  <a:tabLst>
                    <a:tab algn="l" pos="0"/>
                    <a:tab algn="ctr" pos="228600"/>
                    <a:tab algn="ctr" pos="74628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0.11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0.5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200000"/>
                  </a:lnSpc>
                  <a:tabLst>
                    <a:tab algn="l" pos="0"/>
                    <a:tab algn="ctr" pos="228600"/>
                    <a:tab algn="ctr" pos="74628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200000"/>
                  </a:lnSpc>
                  <a:tabLst>
                    <a:tab algn="l" pos="0"/>
                    <a:tab algn="ctr" pos="228600"/>
                    <a:tab algn="ctr" pos="74628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0.6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200000"/>
                  </a:lnSpc>
                  <a:tabLst>
                    <a:tab algn="l" pos="0"/>
                    <a:tab algn="ctr" pos="228600"/>
                    <a:tab algn="ctr" pos="74628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0.5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200000"/>
                  </a:lnSpc>
                  <a:tabLst>
                    <a:tab algn="l" pos="0"/>
                    <a:tab algn="ctr" pos="228600"/>
                    <a:tab algn="ctr" pos="74628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200000"/>
                  </a:lnSpc>
                  <a:tabLst>
                    <a:tab algn="l" pos="0"/>
                    <a:tab algn="ctr" pos="228600"/>
                    <a:tab algn="ctr" pos="74628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11.5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0.6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200000"/>
                  </a:lnSpc>
                  <a:tabLst>
                    <a:tab algn="l" pos="0"/>
                    <a:tab algn="ctr" pos="228600"/>
                    <a:tab algn="ctr" pos="74628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13.0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0.5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200000"/>
                  </a:lnSpc>
                  <a:tabLst>
                    <a:tab algn="l" pos="0"/>
                    <a:tab algn="ctr" pos="228600"/>
                    <a:tab algn="ctr" pos="74628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15.6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0.3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200000"/>
                  </a:lnSpc>
                  <a:tabLst>
                    <a:tab algn="l" pos="0"/>
                    <a:tab algn="ctr" pos="228600"/>
                    <a:tab algn="ctr" pos="74628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     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averag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200000"/>
                  </a:lnSpc>
                  <a:tabLst>
                    <a:tab algn="l" pos="0"/>
                    <a:tab algn="ctr" pos="228600"/>
                    <a:tab algn="ctr" pos="74628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l-GR" sz="1200" spc="-1" strike="noStrike">
                    <a:solidFill>
                      <a:srgbClr val="000000"/>
                    </a:solidFill>
                    <a:latin typeface="Arial"/>
                  </a:rPr>
                  <a:t>μ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g/ml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F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4078080" y="2284200"/>
                <a:ext cx="4449240" cy="337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C. lovastati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4076280" y="3414600"/>
                <a:ext cx="4483080" cy="337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D. dyclonine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8" name=""/>
              <p:cNvGrpSpPr/>
              <p:nvPr/>
            </p:nvGrpSpPr>
            <p:grpSpPr>
              <a:xfrm>
                <a:off x="6232320" y="1330200"/>
                <a:ext cx="2100240" cy="276480"/>
                <a:chOff x="6232320" y="1330200"/>
                <a:chExt cx="2100240" cy="276480"/>
              </a:xfrm>
            </p:grpSpPr>
            <p:sp>
              <p:nvSpPr>
                <p:cNvPr id="49" name=""/>
                <p:cNvSpPr/>
                <p:nvPr/>
              </p:nvSpPr>
              <p:spPr>
                <a:xfrm>
                  <a:off x="6232320" y="1382400"/>
                  <a:ext cx="142560" cy="142560"/>
                </a:xfrm>
                <a:prstGeom prst="diamond">
                  <a:avLst/>
                </a:prstGeom>
                <a:solidFill>
                  <a:srgbClr val="ff0000"/>
                </a:solidFill>
                <a:ln w="324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4480" bIns="244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"/>
                <p:cNvSpPr/>
                <p:nvPr/>
              </p:nvSpPr>
              <p:spPr>
                <a:xfrm>
                  <a:off x="6975000" y="1372680"/>
                  <a:ext cx="142560" cy="142560"/>
                </a:xfrm>
                <a:prstGeom prst="diamond">
                  <a:avLst/>
                </a:prstGeom>
                <a:solidFill>
                  <a:srgbClr val="ffffff"/>
                </a:solidFill>
                <a:ln w="324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4480" bIns="244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"/>
                <p:cNvSpPr/>
                <p:nvPr/>
              </p:nvSpPr>
              <p:spPr>
                <a:xfrm>
                  <a:off x="7765200" y="1382400"/>
                  <a:ext cx="113760" cy="13284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520" bIns="-252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"/>
                <p:cNvSpPr/>
                <p:nvPr/>
              </p:nvSpPr>
              <p:spPr>
                <a:xfrm>
                  <a:off x="6283080" y="1330200"/>
                  <a:ext cx="2049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743040"/>
                      <a:tab algn="l" pos="148608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RG1 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	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CDR1 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	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YPT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3" name=""/>
              <p:cNvGrpSpPr/>
              <p:nvPr/>
            </p:nvGrpSpPr>
            <p:grpSpPr>
              <a:xfrm>
                <a:off x="5412960" y="5136840"/>
                <a:ext cx="2993040" cy="513720"/>
                <a:chOff x="5412960" y="5136840"/>
                <a:chExt cx="2993040" cy="513720"/>
              </a:xfrm>
            </p:grpSpPr>
            <p:sp>
              <p:nvSpPr>
                <p:cNvPr id="54" name=""/>
                <p:cNvSpPr/>
                <p:nvPr/>
              </p:nvSpPr>
              <p:spPr>
                <a:xfrm>
                  <a:off x="5412960" y="5211360"/>
                  <a:ext cx="142560" cy="142920"/>
                </a:xfrm>
                <a:prstGeom prst="diamond">
                  <a:avLst/>
                </a:prstGeom>
                <a:solidFill>
                  <a:srgbClr val="008000"/>
                </a:solidFill>
                <a:ln w="3240">
                  <a:solidFill>
                    <a:srgbClr val="008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4840" bIns="2484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"/>
                <p:cNvSpPr/>
                <p:nvPr/>
              </p:nvSpPr>
              <p:spPr>
                <a:xfrm>
                  <a:off x="6222600" y="5202000"/>
                  <a:ext cx="142560" cy="142920"/>
                </a:xfrm>
                <a:prstGeom prst="diamond">
                  <a:avLst/>
                </a:prstGeom>
                <a:solidFill>
                  <a:srgbClr val="00ffcc"/>
                </a:solidFill>
                <a:ln w="3240">
                  <a:solidFill>
                    <a:srgbClr val="00ffc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4840" bIns="2484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"/>
                <p:cNvSpPr/>
                <p:nvPr/>
              </p:nvSpPr>
              <p:spPr>
                <a:xfrm>
                  <a:off x="7041600" y="5211360"/>
                  <a:ext cx="114120" cy="13356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ff6600"/>
                </a:solidFill>
                <a:ln w="3240">
                  <a:solidFill>
                    <a:srgbClr val="ff66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160" bIns="-2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"/>
                <p:cNvSpPr/>
                <p:nvPr/>
              </p:nvSpPr>
              <p:spPr>
                <a:xfrm>
                  <a:off x="5464440" y="5136840"/>
                  <a:ext cx="2941560" cy="513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15000"/>
                    </a:lnSpc>
                    <a:tabLst>
                      <a:tab algn="l" pos="0"/>
                      <a:tab algn="l" pos="800280"/>
                      <a:tab algn="l" pos="1600200"/>
                      <a:tab algn="l" pos="234648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RG24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	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RG2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	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HMG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15000"/>
                    </a:lnSpc>
                    <a:tabLst>
                      <a:tab algn="l" pos="0"/>
                      <a:tab algn="l" pos="800280"/>
                      <a:tab algn="l" pos="1600200"/>
                      <a:tab algn="l" pos="234648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RG20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	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RG19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	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RG12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	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CDR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"/>
                <p:cNvSpPr/>
                <p:nvPr/>
              </p:nvSpPr>
              <p:spPr>
                <a:xfrm>
                  <a:off x="5422320" y="5430600"/>
                  <a:ext cx="114480" cy="13320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993366"/>
                </a:solidFill>
                <a:ln w="3240">
                  <a:solidFill>
                    <a:srgbClr val="99336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160" bIns="-2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"/>
                <p:cNvSpPr/>
                <p:nvPr/>
              </p:nvSpPr>
              <p:spPr>
                <a:xfrm>
                  <a:off x="6241320" y="5430600"/>
                  <a:ext cx="114480" cy="13320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ffff00"/>
                </a:solidFill>
                <a:ln w="3240">
                  <a:solidFill>
                    <a:srgbClr val="ffff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160" bIns="-2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>
                  <a:off x="7032240" y="5430600"/>
                  <a:ext cx="114120" cy="13320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cc00cc"/>
                </a:solidFill>
                <a:ln w="3240">
                  <a:solidFill>
                    <a:srgbClr val="cc00c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160" bIns="-2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"/>
                <p:cNvSpPr/>
                <p:nvPr/>
              </p:nvSpPr>
              <p:spPr>
                <a:xfrm>
                  <a:off x="7781400" y="5425920"/>
                  <a:ext cx="114120" cy="13320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808080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2160" bIns="-21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2" name=""/>
              <p:cNvSpPr/>
              <p:nvPr/>
            </p:nvSpPr>
            <p:spPr>
              <a:xfrm>
                <a:off x="5761800" y="856800"/>
                <a:ext cx="1564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normalized 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z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-scor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3" name=""/>
              <p:cNvGrpSpPr/>
              <p:nvPr/>
            </p:nvGrpSpPr>
            <p:grpSpPr>
              <a:xfrm>
                <a:off x="6902280" y="2428560"/>
                <a:ext cx="1475640" cy="276480"/>
                <a:chOff x="6902280" y="2428560"/>
                <a:chExt cx="1475640" cy="276480"/>
              </a:xfrm>
            </p:grpSpPr>
            <p:sp>
              <p:nvSpPr>
                <p:cNvPr id="64" name=""/>
                <p:cNvSpPr/>
                <p:nvPr/>
              </p:nvSpPr>
              <p:spPr>
                <a:xfrm>
                  <a:off x="6902280" y="2481120"/>
                  <a:ext cx="142560" cy="142920"/>
                </a:xfrm>
                <a:prstGeom prst="diamond">
                  <a:avLst/>
                </a:prstGeom>
                <a:solidFill>
                  <a:srgbClr val="3333ff"/>
                </a:solidFill>
                <a:ln w="3240">
                  <a:solidFill>
                    <a:srgbClr val="3333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4840" bIns="2484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>
                  <a:off x="7644960" y="2471400"/>
                  <a:ext cx="142560" cy="142920"/>
                </a:xfrm>
                <a:prstGeom prst="diamond">
                  <a:avLst/>
                </a:prstGeom>
                <a:solidFill>
                  <a:srgbClr val="ffffff"/>
                </a:solidFill>
                <a:ln w="3240">
                  <a:solidFill>
                    <a:srgbClr val="3333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4840" bIns="2484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>
                  <a:off x="6952680" y="2428560"/>
                  <a:ext cx="14252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743040"/>
                      <a:tab algn="l" pos="148608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HMG1 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	</a:t>
                  </a:r>
                  <a:r>
                    <a:rPr b="1" i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ERG1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pic>
          <p:nvPicPr>
            <p:cNvPr id="67" name="" descr=""/>
            <p:cNvPicPr/>
            <p:nvPr/>
          </p:nvPicPr>
          <p:blipFill>
            <a:blip r:embed="rId2"/>
            <a:stretch/>
          </p:blipFill>
          <p:spPr>
            <a:xfrm>
              <a:off x="466560" y="1126800"/>
              <a:ext cx="3427560" cy="4934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"/>
            <p:cNvSpPr/>
            <p:nvPr/>
          </p:nvSpPr>
          <p:spPr>
            <a:xfrm>
              <a:off x="679320" y="37584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rot="16200000">
              <a:off x="1893240" y="-709200"/>
              <a:ext cx="1140840" cy="265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Terbinafin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1.0 </a:t>
              </a:r>
              <a:r>
                <a:rPr b="1" lang="el-GR" sz="1400" spc="-1" strike="noStrike">
                  <a:solidFill>
                    <a:srgbClr val="000000"/>
                  </a:solidFill>
                  <a:latin typeface="Arial"/>
                </a:rPr>
                <a:t>μ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g/m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Lovastati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50 </a:t>
              </a:r>
              <a:r>
                <a:rPr b="1" lang="el-GR" sz="1400" spc="-1" strike="noStrike">
                  <a:solidFill>
                    <a:srgbClr val="000000"/>
                  </a:solidFill>
                  <a:latin typeface="Arial"/>
                </a:rPr>
                <a:t>μ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g/m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Dyclonin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35 </a:t>
              </a:r>
              <a:r>
                <a:rPr b="1" lang="el-GR" sz="1400" spc="-1" strike="noStrike">
                  <a:solidFill>
                    <a:srgbClr val="000000"/>
                  </a:solidFill>
                  <a:latin typeface="Arial"/>
                </a:rPr>
                <a:t>μ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g/m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"/>
          <p:cNvSpPr/>
          <p:nvPr/>
        </p:nvSpPr>
        <p:spPr>
          <a:xfrm>
            <a:off x="246240" y="6078600"/>
            <a:ext cx="85960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CaFT profiles of inhibitors of enzymes involved in ergosterol biosynthesis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Spot tests of terbinafine, lovastatin and dyclonine against heterozygous deletion strains corresponding to enzymes involved in ergosterol biosynthesis and the control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HIS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. CaFT profiles of terbinafine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lovastatin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and dyclonine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1T14:39:44Z</dcterms:created>
  <dc:creator>xudemin</dc:creator>
  <dc:description/>
  <dc:language>en-US</dc:language>
  <cp:lastModifiedBy>xudemin</cp:lastModifiedBy>
  <dcterms:modified xsi:type="dcterms:W3CDTF">2007-05-17T15:22:35Z</dcterms:modified>
  <cp:revision>4</cp:revision>
  <dc:subject/>
  <dc:title>Slide 1</dc:title>
</cp:coreProperties>
</file>